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png" ContentType="image/png"/>
  <Override PartName="/ppt/media/image7.png" ContentType="image/pn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9947275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9946800" cy="6858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43099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5635800" y="-360"/>
            <a:ext cx="43099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4008600" y="514440"/>
            <a:ext cx="1930320" cy="2571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95040" y="3257640"/>
            <a:ext cx="7956360" cy="308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6513120"/>
            <a:ext cx="43099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5635800" y="6513120"/>
            <a:ext cx="43099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AAB2BC-81A6-47F8-8C73-C7A4636170D6}" type="slidenum"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sldImg"/>
          </p:nvPr>
        </p:nvSpPr>
        <p:spPr>
          <a:xfrm>
            <a:off x="4008600" y="514440"/>
            <a:ext cx="1930320" cy="2571840"/>
          </a:xfrm>
          <a:prstGeom prst="rect">
            <a:avLst/>
          </a:prstGeom>
          <a:ln w="0">
            <a:noFill/>
          </a:ln>
        </p:spPr>
      </p:sp>
      <p:sp>
        <p:nvSpPr>
          <p:cNvPr id="135" name="PlaceHolder 2"/>
          <p:cNvSpPr>
            <a:spLocks noGrp="1"/>
          </p:cNvSpPr>
          <p:nvPr>
            <p:ph type="body"/>
          </p:nvPr>
        </p:nvSpPr>
        <p:spPr>
          <a:xfrm>
            <a:off x="995040" y="3257640"/>
            <a:ext cx="7956360" cy="308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27 mRNA expression in cell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灯片编号占位符 3"/>
          <p:cNvSpPr/>
          <p:nvPr/>
        </p:nvSpPr>
        <p:spPr>
          <a:xfrm>
            <a:off x="5635800" y="6513480"/>
            <a:ext cx="43099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B74386-52A8-43D5-89E2-5B7B77F7B976}" type="slidenum"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98FB54-9905-4BB5-8BE5-D60296BD560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B39607-37DB-4A74-9C08-77D9CA1CA2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295600-16CD-4A10-B460-196E1DF252E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DB012C-E338-4BB6-9D32-E4E2D4D280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DACE7B-DA33-457C-BE79-DE5B5D950C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55073C-77E1-468A-9949-FBE7FBC126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7C681B-8C40-40A3-A5B2-3E4EE0B1D7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C08D04-B094-453F-8F5E-2C9BE8B43B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0A287F-0F87-46EC-9EC7-E48EBF079A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6B2E92-D7B4-4231-B0F0-9323AB9BEC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D37C04-4325-4D9D-B2A3-1939DDF556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65F19F-9EEA-4142-9FAD-E2622FA72F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675DF9-4B91-482D-B3D9-FA8E92DB9DCE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2.jpeg"/><Relationship Id="rId6" Type="http://schemas.openxmlformats.org/officeDocument/2006/relationships/image" Target="../media/image5.jpe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jpeg"/><Relationship Id="rId10" Type="http://schemas.openxmlformats.org/officeDocument/2006/relationships/image" Target="../media/image9.jpeg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26"/>
          <p:cNvGrpSpPr/>
          <p:nvPr/>
        </p:nvGrpSpPr>
        <p:grpSpPr>
          <a:xfrm>
            <a:off x="199440" y="514440"/>
            <a:ext cx="6618960" cy="2559960"/>
            <a:chOff x="199440" y="514440"/>
            <a:chExt cx="6618960" cy="2559960"/>
          </a:xfrm>
        </p:grpSpPr>
        <p:sp>
          <p:nvSpPr>
            <p:cNvPr id="49" name="Text Box 6"/>
            <p:cNvSpPr/>
            <p:nvPr/>
          </p:nvSpPr>
          <p:spPr>
            <a:xfrm>
              <a:off x="199440" y="51444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50" name="Group 195"/>
            <p:cNvGrpSpPr/>
            <p:nvPr/>
          </p:nvGrpSpPr>
          <p:grpSpPr>
            <a:xfrm>
              <a:off x="256680" y="1178640"/>
              <a:ext cx="1001160" cy="397440"/>
              <a:chOff x="256680" y="1178640"/>
              <a:chExt cx="1001160" cy="397440"/>
            </a:xfrm>
          </p:grpSpPr>
          <p:sp>
            <p:nvSpPr>
              <p:cNvPr id="51" name="AutoShape 196"/>
              <p:cNvSpPr/>
              <p:nvPr/>
            </p:nvSpPr>
            <p:spPr>
              <a:xfrm rot="20772000">
                <a:off x="526680" y="1373040"/>
                <a:ext cx="504720" cy="144720"/>
              </a:xfrm>
              <a:prstGeom prst="diamond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5920" bIns="2592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" name="AutoShape 197"/>
              <p:cNvSpPr/>
              <p:nvPr/>
            </p:nvSpPr>
            <p:spPr>
              <a:xfrm rot="20772000">
                <a:off x="266400" y="1361880"/>
                <a:ext cx="504720" cy="144720"/>
              </a:xfrm>
              <a:prstGeom prst="diamond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5920" bIns="2592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" name="AutoShape 198"/>
              <p:cNvSpPr/>
              <p:nvPr/>
            </p:nvSpPr>
            <p:spPr>
              <a:xfrm rot="20772000">
                <a:off x="743040" y="1236960"/>
                <a:ext cx="504720" cy="144360"/>
              </a:xfrm>
              <a:prstGeom prst="diamond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5560" bIns="255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" name="AutoShape 199"/>
              <p:cNvSpPr/>
              <p:nvPr/>
            </p:nvSpPr>
            <p:spPr>
              <a:xfrm rot="20772000">
                <a:off x="465120" y="1236600"/>
                <a:ext cx="505080" cy="144360"/>
              </a:xfrm>
              <a:prstGeom prst="diamond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5560" bIns="255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" name="Oval 200"/>
              <p:cNvSpPr/>
              <p:nvPr/>
            </p:nvSpPr>
            <p:spPr>
              <a:xfrm rot="9000000">
                <a:off x="452160" y="1404720"/>
                <a:ext cx="108000" cy="65160"/>
              </a:xfrm>
              <a:prstGeom prst="ellipse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60" bIns="-360" anchor="ctr" rot="10800000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" name="Oval 201"/>
              <p:cNvSpPr/>
              <p:nvPr/>
            </p:nvSpPr>
            <p:spPr>
              <a:xfrm rot="9000000">
                <a:off x="668160" y="1268280"/>
                <a:ext cx="108000" cy="65160"/>
              </a:xfrm>
              <a:prstGeom prst="ellipse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60" bIns="-360" anchor="ctr" rot="10800000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7" name="Oval 202"/>
              <p:cNvSpPr/>
              <p:nvPr/>
            </p:nvSpPr>
            <p:spPr>
              <a:xfrm rot="9000000">
                <a:off x="738000" y="1407960"/>
                <a:ext cx="108000" cy="65160"/>
              </a:xfrm>
              <a:prstGeom prst="ellipse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60" bIns="-360" anchor="ctr" rot="10800000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8" name="Oval 203"/>
              <p:cNvSpPr/>
              <p:nvPr/>
            </p:nvSpPr>
            <p:spPr>
              <a:xfrm rot="9000000">
                <a:off x="939960" y="1278360"/>
                <a:ext cx="108000" cy="64800"/>
              </a:xfrm>
              <a:prstGeom prst="ellipse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" bIns="-720" anchor="ctr" rot="10800000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59" name="Line 204"/>
            <p:cNvSpPr/>
            <p:nvPr/>
          </p:nvSpPr>
          <p:spPr>
            <a:xfrm flipV="1">
              <a:off x="1267920" y="1375560"/>
              <a:ext cx="341640" cy="4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480" bIns="-42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Text Box 205"/>
            <p:cNvSpPr/>
            <p:nvPr/>
          </p:nvSpPr>
          <p:spPr>
            <a:xfrm>
              <a:off x="317160" y="891000"/>
              <a:ext cx="944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PFA crosslink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Text Box 206"/>
            <p:cNvSpPr/>
            <p:nvPr/>
          </p:nvSpPr>
          <p:spPr>
            <a:xfrm>
              <a:off x="1804680" y="1905480"/>
              <a:ext cx="9745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Protein-</a:t>
              </a: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</a:rPr>
                <a:t>RNA</a:t>
              </a: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 complex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Line 207"/>
            <p:cNvSpPr/>
            <p:nvPr/>
          </p:nvSpPr>
          <p:spPr>
            <a:xfrm flipV="1">
              <a:off x="2760480" y="1370160"/>
              <a:ext cx="341280" cy="5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Text Box 208"/>
            <p:cNvSpPr/>
            <p:nvPr/>
          </p:nvSpPr>
          <p:spPr>
            <a:xfrm>
              <a:off x="1459080" y="928800"/>
              <a:ext cx="1038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Polysome lysate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Text Box 209"/>
            <p:cNvSpPr/>
            <p:nvPr/>
          </p:nvSpPr>
          <p:spPr>
            <a:xfrm>
              <a:off x="3441960" y="814680"/>
              <a:ext cx="1058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ff00"/>
                  </a:solidFill>
                  <a:latin typeface="Times New Roman"/>
                </a:rPr>
                <a:t>Anti-GFP</a:t>
              </a: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 bead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Text Box 210"/>
            <p:cNvSpPr/>
            <p:nvPr/>
          </p:nvSpPr>
          <p:spPr>
            <a:xfrm>
              <a:off x="2633400" y="946800"/>
              <a:ext cx="11005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Immuno-precipitati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Line 211"/>
            <p:cNvSpPr/>
            <p:nvPr/>
          </p:nvSpPr>
          <p:spPr>
            <a:xfrm flipV="1">
              <a:off x="4992480" y="1369080"/>
              <a:ext cx="341640" cy="4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480" bIns="-42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Text Box 212"/>
            <p:cNvSpPr/>
            <p:nvPr/>
          </p:nvSpPr>
          <p:spPr>
            <a:xfrm>
              <a:off x="4998960" y="954360"/>
              <a:ext cx="8762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RN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extracti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Freeform 213"/>
            <p:cNvSpPr/>
            <p:nvPr/>
          </p:nvSpPr>
          <p:spPr>
            <a:xfrm flipV="1" rot="18376200">
              <a:off x="5304240" y="1330200"/>
              <a:ext cx="796680" cy="306360"/>
            </a:xfrm>
            <a:custGeom>
              <a:avLst/>
              <a:gdLst>
                <a:gd name="textAreaLeft" fmla="*/ 0 w 796680"/>
                <a:gd name="textAreaRight" fmla="*/ 797040 w 796680"/>
                <a:gd name="textAreaTop" fmla="*/ -360 h 306360"/>
                <a:gd name="textAreaBottom" fmla="*/ 306360 h 306360"/>
              </a:gdLst>
              <a:ahLst/>
              <a:rect l="textAreaLeft" t="textAreaTop" r="textAreaRight" b="textAreaBottom"/>
              <a:pathLst>
                <a:path w="961" h="401">
                  <a:moveTo>
                    <a:pt x="0" y="401"/>
                  </a:moveTo>
                  <a:cubicBezTo>
                    <a:pt x="60" y="321"/>
                    <a:pt x="121" y="242"/>
                    <a:pt x="227" y="219"/>
                  </a:cubicBezTo>
                  <a:cubicBezTo>
                    <a:pt x="333" y="196"/>
                    <a:pt x="522" y="295"/>
                    <a:pt x="635" y="265"/>
                  </a:cubicBezTo>
                  <a:cubicBezTo>
                    <a:pt x="748" y="235"/>
                    <a:pt x="855" y="76"/>
                    <a:pt x="908" y="38"/>
                  </a:cubicBezTo>
                  <a:cubicBezTo>
                    <a:pt x="961" y="0"/>
                    <a:pt x="957" y="19"/>
                    <a:pt x="953" y="38"/>
                  </a:cubicBezTo>
                </a:path>
              </a:pathLst>
            </a:custGeom>
            <a:noFill/>
            <a:ln w="63360">
              <a:solidFill>
                <a:srgbClr val="ff0000"/>
              </a:solidFill>
              <a:prstDash val="sysDot"/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Line 214"/>
            <p:cNvSpPr/>
            <p:nvPr/>
          </p:nvSpPr>
          <p:spPr>
            <a:xfrm flipH="1">
              <a:off x="5686200" y="1757160"/>
              <a:ext cx="2880" cy="48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Text Box 215"/>
            <p:cNvSpPr/>
            <p:nvPr/>
          </p:nvSpPr>
          <p:spPr>
            <a:xfrm>
              <a:off x="5667840" y="1692720"/>
              <a:ext cx="115056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Whole transcriptome amplicati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71" name="Group 49"/>
            <p:cNvGrpSpPr/>
            <p:nvPr/>
          </p:nvGrpSpPr>
          <p:grpSpPr>
            <a:xfrm>
              <a:off x="5256360" y="2223360"/>
              <a:ext cx="857520" cy="851040"/>
              <a:chOff x="5256360" y="2223360"/>
              <a:chExt cx="857520" cy="851040"/>
            </a:xfrm>
          </p:grpSpPr>
          <p:sp>
            <p:nvSpPr>
              <p:cNvPr id="72" name="Freeform 217"/>
              <p:cNvSpPr/>
              <p:nvPr/>
            </p:nvSpPr>
            <p:spPr>
              <a:xfrm flipV="1" rot="20820000">
                <a:off x="5280480" y="2308680"/>
                <a:ext cx="795240" cy="305640"/>
              </a:xfrm>
              <a:custGeom>
                <a:avLst/>
                <a:gdLst>
                  <a:gd name="textAreaLeft" fmla="*/ 0 w 795240"/>
                  <a:gd name="textAreaRight" fmla="*/ 795600 w 795240"/>
                  <a:gd name="textAreaTop" fmla="*/ -360 h 305640"/>
                  <a:gd name="textAreaBottom" fmla="*/ 305640 h 305640"/>
                </a:gdLst>
                <a:ahLst/>
                <a:rect l="textAreaLeft" t="textAreaTop" r="textAreaRight" b="textAreaBottom"/>
                <a:pathLst>
                  <a:path w="961" h="401">
                    <a:moveTo>
                      <a:pt x="0" y="401"/>
                    </a:moveTo>
                    <a:cubicBezTo>
                      <a:pt x="60" y="321"/>
                      <a:pt x="121" y="242"/>
                      <a:pt x="227" y="219"/>
                    </a:cubicBezTo>
                    <a:cubicBezTo>
                      <a:pt x="333" y="196"/>
                      <a:pt x="522" y="295"/>
                      <a:pt x="635" y="265"/>
                    </a:cubicBezTo>
                    <a:cubicBezTo>
                      <a:pt x="748" y="235"/>
                      <a:pt x="855" y="76"/>
                      <a:pt x="908" y="38"/>
                    </a:cubicBezTo>
                    <a:cubicBezTo>
                      <a:pt x="961" y="0"/>
                      <a:pt x="957" y="19"/>
                      <a:pt x="953" y="38"/>
                    </a:cubicBezTo>
                  </a:path>
                </a:pathLst>
              </a:custGeom>
              <a:noFill/>
              <a:ln w="63360">
                <a:solidFill>
                  <a:srgbClr val="ff0000"/>
                </a:solidFill>
                <a:prstDash val="sysDot"/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3" name="Freeform 218"/>
              <p:cNvSpPr/>
              <p:nvPr/>
            </p:nvSpPr>
            <p:spPr>
              <a:xfrm flipV="1" rot="20820000">
                <a:off x="5280480" y="2429640"/>
                <a:ext cx="795240" cy="305640"/>
              </a:xfrm>
              <a:custGeom>
                <a:avLst/>
                <a:gdLst>
                  <a:gd name="textAreaLeft" fmla="*/ 0 w 795240"/>
                  <a:gd name="textAreaRight" fmla="*/ 795600 w 795240"/>
                  <a:gd name="textAreaTop" fmla="*/ -360 h 305640"/>
                  <a:gd name="textAreaBottom" fmla="*/ 305640 h 305640"/>
                </a:gdLst>
                <a:ahLst/>
                <a:rect l="textAreaLeft" t="textAreaTop" r="textAreaRight" b="textAreaBottom"/>
                <a:pathLst>
                  <a:path w="961" h="401">
                    <a:moveTo>
                      <a:pt x="0" y="401"/>
                    </a:moveTo>
                    <a:cubicBezTo>
                      <a:pt x="60" y="321"/>
                      <a:pt x="121" y="242"/>
                      <a:pt x="227" y="219"/>
                    </a:cubicBezTo>
                    <a:cubicBezTo>
                      <a:pt x="333" y="196"/>
                      <a:pt x="522" y="295"/>
                      <a:pt x="635" y="265"/>
                    </a:cubicBezTo>
                    <a:cubicBezTo>
                      <a:pt x="748" y="235"/>
                      <a:pt x="855" y="76"/>
                      <a:pt x="908" y="38"/>
                    </a:cubicBezTo>
                    <a:cubicBezTo>
                      <a:pt x="961" y="0"/>
                      <a:pt x="957" y="19"/>
                      <a:pt x="953" y="38"/>
                    </a:cubicBezTo>
                  </a:path>
                </a:pathLst>
              </a:custGeom>
              <a:noFill/>
              <a:ln w="63360">
                <a:solidFill>
                  <a:srgbClr val="ff0000"/>
                </a:solidFill>
                <a:prstDash val="sysDot"/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4" name="Freeform 219"/>
              <p:cNvSpPr/>
              <p:nvPr/>
            </p:nvSpPr>
            <p:spPr>
              <a:xfrm flipV="1" rot="20820000">
                <a:off x="5280480" y="2558880"/>
                <a:ext cx="795240" cy="305640"/>
              </a:xfrm>
              <a:custGeom>
                <a:avLst/>
                <a:gdLst>
                  <a:gd name="textAreaLeft" fmla="*/ 0 w 795240"/>
                  <a:gd name="textAreaRight" fmla="*/ 795600 w 795240"/>
                  <a:gd name="textAreaTop" fmla="*/ -360 h 305640"/>
                  <a:gd name="textAreaBottom" fmla="*/ 305640 h 305640"/>
                </a:gdLst>
                <a:ahLst/>
                <a:rect l="textAreaLeft" t="textAreaTop" r="textAreaRight" b="textAreaBottom"/>
                <a:pathLst>
                  <a:path w="961" h="401">
                    <a:moveTo>
                      <a:pt x="0" y="401"/>
                    </a:moveTo>
                    <a:cubicBezTo>
                      <a:pt x="60" y="321"/>
                      <a:pt x="121" y="242"/>
                      <a:pt x="227" y="219"/>
                    </a:cubicBezTo>
                    <a:cubicBezTo>
                      <a:pt x="333" y="196"/>
                      <a:pt x="522" y="295"/>
                      <a:pt x="635" y="265"/>
                    </a:cubicBezTo>
                    <a:cubicBezTo>
                      <a:pt x="748" y="235"/>
                      <a:pt x="855" y="76"/>
                      <a:pt x="908" y="38"/>
                    </a:cubicBezTo>
                    <a:cubicBezTo>
                      <a:pt x="961" y="0"/>
                      <a:pt x="957" y="19"/>
                      <a:pt x="953" y="38"/>
                    </a:cubicBezTo>
                  </a:path>
                </a:pathLst>
              </a:custGeom>
              <a:noFill/>
              <a:ln w="63360">
                <a:solidFill>
                  <a:srgbClr val="ff0000"/>
                </a:solidFill>
                <a:prstDash val="sysDot"/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5" name="Freeform 220"/>
              <p:cNvSpPr/>
              <p:nvPr/>
            </p:nvSpPr>
            <p:spPr>
              <a:xfrm flipV="1" rot="20820000">
                <a:off x="5293440" y="2681640"/>
                <a:ext cx="795960" cy="306720"/>
              </a:xfrm>
              <a:custGeom>
                <a:avLst/>
                <a:gdLst>
                  <a:gd name="textAreaLeft" fmla="*/ 0 w 795960"/>
                  <a:gd name="textAreaRight" fmla="*/ 796320 w 795960"/>
                  <a:gd name="textAreaTop" fmla="*/ 360 h 306720"/>
                  <a:gd name="textAreaBottom" fmla="*/ 307440 h 306720"/>
                </a:gdLst>
                <a:ahLst/>
                <a:rect l="textAreaLeft" t="textAreaTop" r="textAreaRight" b="textAreaBottom"/>
                <a:pathLst>
                  <a:path w="961" h="401">
                    <a:moveTo>
                      <a:pt x="0" y="401"/>
                    </a:moveTo>
                    <a:cubicBezTo>
                      <a:pt x="60" y="321"/>
                      <a:pt x="121" y="242"/>
                      <a:pt x="227" y="219"/>
                    </a:cubicBezTo>
                    <a:cubicBezTo>
                      <a:pt x="333" y="196"/>
                      <a:pt x="522" y="295"/>
                      <a:pt x="635" y="265"/>
                    </a:cubicBezTo>
                    <a:cubicBezTo>
                      <a:pt x="748" y="235"/>
                      <a:pt x="855" y="76"/>
                      <a:pt x="908" y="38"/>
                    </a:cubicBezTo>
                    <a:cubicBezTo>
                      <a:pt x="961" y="0"/>
                      <a:pt x="957" y="19"/>
                      <a:pt x="953" y="38"/>
                    </a:cubicBezTo>
                  </a:path>
                </a:pathLst>
              </a:custGeom>
              <a:noFill/>
              <a:ln w="63360">
                <a:solidFill>
                  <a:srgbClr val="ff0000"/>
                </a:solidFill>
                <a:prstDash val="sysDot"/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76" name="Line 221"/>
            <p:cNvSpPr/>
            <p:nvPr/>
          </p:nvSpPr>
          <p:spPr>
            <a:xfrm flipH="1">
              <a:off x="4776840" y="2597760"/>
              <a:ext cx="341280" cy="4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480" bIns="-42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Text Box 222"/>
            <p:cNvSpPr/>
            <p:nvPr/>
          </p:nvSpPr>
          <p:spPr>
            <a:xfrm>
              <a:off x="3347280" y="2280240"/>
              <a:ext cx="108288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Illumin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High-throughou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sequencing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Line 223"/>
            <p:cNvSpPr/>
            <p:nvPr/>
          </p:nvSpPr>
          <p:spPr>
            <a:xfrm flipH="1">
              <a:off x="2936520" y="2632680"/>
              <a:ext cx="340920" cy="4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480" bIns="-42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Text Box 224"/>
            <p:cNvSpPr/>
            <p:nvPr/>
          </p:nvSpPr>
          <p:spPr>
            <a:xfrm>
              <a:off x="1796040" y="2386440"/>
              <a:ext cx="9136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Bioinformatic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analysi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Line 225"/>
            <p:cNvSpPr/>
            <p:nvPr/>
          </p:nvSpPr>
          <p:spPr>
            <a:xfrm flipH="1">
              <a:off x="1352160" y="2632680"/>
              <a:ext cx="340920" cy="4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480" bIns="-42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Text Box 226"/>
            <p:cNvSpPr/>
            <p:nvPr/>
          </p:nvSpPr>
          <p:spPr>
            <a:xfrm>
              <a:off x="313560" y="2379960"/>
              <a:ext cx="8924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Experimental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</a:rPr>
                <a:t>validati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82" name="Group 60"/>
            <p:cNvGrpSpPr/>
            <p:nvPr/>
          </p:nvGrpSpPr>
          <p:grpSpPr>
            <a:xfrm>
              <a:off x="1766880" y="1174320"/>
              <a:ext cx="833040" cy="848160"/>
              <a:chOff x="1766880" y="1174320"/>
              <a:chExt cx="833040" cy="848160"/>
            </a:xfrm>
          </p:grpSpPr>
          <p:sp>
            <p:nvSpPr>
              <p:cNvPr id="83" name="Oval 229"/>
              <p:cNvSpPr/>
              <p:nvPr/>
            </p:nvSpPr>
            <p:spPr>
              <a:xfrm>
                <a:off x="2223360" y="1586160"/>
                <a:ext cx="339480" cy="237960"/>
              </a:xfrm>
              <a:prstGeom prst="ellipse">
                <a:avLst/>
              </a:prstGeom>
              <a:solidFill>
                <a:srgbClr val="008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4" name="Freeform 230"/>
              <p:cNvSpPr/>
              <p:nvPr/>
            </p:nvSpPr>
            <p:spPr>
              <a:xfrm flipV="1" rot="10291800">
                <a:off x="1784880" y="1367640"/>
                <a:ext cx="796680" cy="306360"/>
              </a:xfrm>
              <a:custGeom>
                <a:avLst/>
                <a:gdLst>
                  <a:gd name="textAreaLeft" fmla="*/ 0 w 796680"/>
                  <a:gd name="textAreaRight" fmla="*/ 797040 w 796680"/>
                  <a:gd name="textAreaTop" fmla="*/ -360 h 306360"/>
                  <a:gd name="textAreaBottom" fmla="*/ 306360 h 306360"/>
                </a:gdLst>
                <a:ahLst/>
                <a:rect l="textAreaLeft" t="textAreaTop" r="textAreaRight" b="textAreaBottom"/>
                <a:pathLst>
                  <a:path w="961" h="401">
                    <a:moveTo>
                      <a:pt x="0" y="401"/>
                    </a:moveTo>
                    <a:cubicBezTo>
                      <a:pt x="60" y="321"/>
                      <a:pt x="121" y="242"/>
                      <a:pt x="227" y="219"/>
                    </a:cubicBezTo>
                    <a:cubicBezTo>
                      <a:pt x="333" y="196"/>
                      <a:pt x="522" y="295"/>
                      <a:pt x="635" y="265"/>
                    </a:cubicBezTo>
                    <a:cubicBezTo>
                      <a:pt x="748" y="235"/>
                      <a:pt x="855" y="76"/>
                      <a:pt x="908" y="38"/>
                    </a:cubicBezTo>
                    <a:cubicBezTo>
                      <a:pt x="961" y="0"/>
                      <a:pt x="957" y="19"/>
                      <a:pt x="953" y="38"/>
                    </a:cubicBezTo>
                  </a:path>
                </a:pathLst>
              </a:custGeom>
              <a:noFill/>
              <a:ln w="63360">
                <a:solidFill>
                  <a:srgbClr val="ff0000"/>
                </a:solidFill>
                <a:prstDash val="sysDot"/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5" name="Freeform 231"/>
              <p:cNvSpPr/>
              <p:nvPr/>
            </p:nvSpPr>
            <p:spPr>
              <a:xfrm rot="2116200">
                <a:off x="1963080" y="1243080"/>
                <a:ext cx="307440" cy="217440"/>
              </a:xfrm>
              <a:custGeom>
                <a:avLst/>
                <a:gdLst>
                  <a:gd name="textAreaLeft" fmla="*/ 0 w 307440"/>
                  <a:gd name="textAreaRight" fmla="*/ 307800 w 307440"/>
                  <a:gd name="textAreaTop" fmla="*/ 0 h 217440"/>
                  <a:gd name="textAreaBottom" fmla="*/ 217800 h 217440"/>
                </a:gdLst>
                <a:ahLst/>
                <a:rect l="textAreaLeft" t="textAreaTop" r="textAreaRight" b="textAreaBottom"/>
                <a:pathLst>
                  <a:path w="961" h="401">
                    <a:moveTo>
                      <a:pt x="0" y="401"/>
                    </a:moveTo>
                    <a:cubicBezTo>
                      <a:pt x="60" y="321"/>
                      <a:pt x="121" y="242"/>
                      <a:pt x="227" y="219"/>
                    </a:cubicBezTo>
                    <a:cubicBezTo>
                      <a:pt x="333" y="196"/>
                      <a:pt x="522" y="295"/>
                      <a:pt x="635" y="265"/>
                    </a:cubicBezTo>
                    <a:cubicBezTo>
                      <a:pt x="748" y="235"/>
                      <a:pt x="855" y="76"/>
                      <a:pt x="908" y="38"/>
                    </a:cubicBezTo>
                    <a:cubicBezTo>
                      <a:pt x="961" y="0"/>
                      <a:pt x="957" y="19"/>
                      <a:pt x="953" y="38"/>
                    </a:cubicBezTo>
                  </a:path>
                </a:pathLst>
              </a:custGeom>
              <a:noFill/>
              <a:ln w="63360">
                <a:solidFill>
                  <a:srgbClr val="ff0000"/>
                </a:solidFill>
                <a:prstDash val="sysDot"/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6" name="Oval 232"/>
              <p:cNvSpPr/>
              <p:nvPr/>
            </p:nvSpPr>
            <p:spPr>
              <a:xfrm>
                <a:off x="1978920" y="1517760"/>
                <a:ext cx="264600" cy="431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7" name="Text Box 233"/>
              <p:cNvSpPr/>
              <p:nvPr/>
            </p:nvSpPr>
            <p:spPr>
              <a:xfrm rot="16200000">
                <a:off x="1813680" y="1603800"/>
                <a:ext cx="6062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ffffff"/>
                    </a:solidFill>
                    <a:latin typeface="Times New Roman"/>
                  </a:rPr>
                  <a:t>PCBP1</a:t>
                </a:r>
                <a:endParaRPr b="0" lang="en-US" sz="9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88" name="Group 66"/>
            <p:cNvGrpSpPr/>
            <p:nvPr/>
          </p:nvGrpSpPr>
          <p:grpSpPr>
            <a:xfrm>
              <a:off x="3285360" y="1101960"/>
              <a:ext cx="1392480" cy="999000"/>
              <a:chOff x="3285360" y="1101960"/>
              <a:chExt cx="1392480" cy="999000"/>
            </a:xfrm>
          </p:grpSpPr>
          <p:sp>
            <p:nvSpPr>
              <p:cNvPr id="89" name="Freeform 236"/>
              <p:cNvSpPr/>
              <p:nvPr/>
            </p:nvSpPr>
            <p:spPr>
              <a:xfrm flipV="1" rot="18420000">
                <a:off x="3915360" y="1535400"/>
                <a:ext cx="798480" cy="307440"/>
              </a:xfrm>
              <a:custGeom>
                <a:avLst/>
                <a:gdLst>
                  <a:gd name="textAreaLeft" fmla="*/ 0 w 798480"/>
                  <a:gd name="textAreaRight" fmla="*/ 798840 w 798480"/>
                  <a:gd name="textAreaTop" fmla="*/ 360 h 307440"/>
                  <a:gd name="textAreaBottom" fmla="*/ 308160 h 307440"/>
                </a:gdLst>
                <a:ahLst/>
                <a:rect l="textAreaLeft" t="textAreaTop" r="textAreaRight" b="textAreaBottom"/>
                <a:pathLst>
                  <a:path w="961" h="401">
                    <a:moveTo>
                      <a:pt x="0" y="401"/>
                    </a:moveTo>
                    <a:cubicBezTo>
                      <a:pt x="60" y="321"/>
                      <a:pt x="121" y="242"/>
                      <a:pt x="227" y="219"/>
                    </a:cubicBezTo>
                    <a:cubicBezTo>
                      <a:pt x="333" y="196"/>
                      <a:pt x="522" y="295"/>
                      <a:pt x="635" y="265"/>
                    </a:cubicBezTo>
                    <a:cubicBezTo>
                      <a:pt x="748" y="235"/>
                      <a:pt x="855" y="76"/>
                      <a:pt x="908" y="38"/>
                    </a:cubicBezTo>
                    <a:cubicBezTo>
                      <a:pt x="961" y="0"/>
                      <a:pt x="957" y="19"/>
                      <a:pt x="953" y="38"/>
                    </a:cubicBezTo>
                  </a:path>
                </a:pathLst>
              </a:custGeom>
              <a:noFill/>
              <a:ln w="63360">
                <a:solidFill>
                  <a:srgbClr val="ff0000"/>
                </a:solidFill>
                <a:prstDash val="sysDot"/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" name="Text Box 242"/>
              <p:cNvSpPr/>
              <p:nvPr/>
            </p:nvSpPr>
            <p:spPr>
              <a:xfrm rot="5880000">
                <a:off x="3701880" y="148104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ff00"/>
                    </a:solidFill>
                    <a:latin typeface="Times New Roman"/>
                  </a:rPr>
                  <a:t>Y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91" name="Group 69"/>
              <p:cNvGrpSpPr/>
              <p:nvPr/>
            </p:nvGrpSpPr>
            <p:grpSpPr>
              <a:xfrm>
                <a:off x="3285360" y="1217160"/>
                <a:ext cx="500040" cy="621000"/>
                <a:chOff x="3285360" y="1217160"/>
                <a:chExt cx="500040" cy="621000"/>
              </a:xfrm>
            </p:grpSpPr>
            <p:sp>
              <p:nvSpPr>
                <p:cNvPr id="92" name="Oval 239"/>
                <p:cNvSpPr/>
                <p:nvPr/>
              </p:nvSpPr>
              <p:spPr>
                <a:xfrm>
                  <a:off x="3496320" y="1406520"/>
                  <a:ext cx="289080" cy="286200"/>
                </a:xfrm>
                <a:prstGeom prst="ellipse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3" name="Oval 240"/>
                <p:cNvSpPr/>
                <p:nvPr/>
              </p:nvSpPr>
              <p:spPr>
                <a:xfrm>
                  <a:off x="3569400" y="1478520"/>
                  <a:ext cx="142920" cy="143280"/>
                </a:xfrm>
                <a:prstGeom prst="ellipse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4" name="Text Box 241"/>
                <p:cNvSpPr/>
                <p:nvPr/>
              </p:nvSpPr>
              <p:spPr>
                <a:xfrm>
                  <a:off x="3490200" y="1217160"/>
                  <a:ext cx="2721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ff00"/>
                      </a:solidFill>
                      <a:latin typeface="Times New Roman"/>
                    </a:rPr>
                    <a:t>Y</a:t>
                  </a:r>
                  <a:endParaRPr b="0" lang="en-US" sz="10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5" name="Text Box 243"/>
                <p:cNvSpPr/>
                <p:nvPr/>
              </p:nvSpPr>
              <p:spPr>
                <a:xfrm rot="14520000">
                  <a:off x="3321720" y="1536840"/>
                  <a:ext cx="2721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ff00"/>
                      </a:solidFill>
                      <a:latin typeface="Times New Roman"/>
                    </a:rPr>
                    <a:t>Y</a:t>
                  </a:r>
                  <a:endParaRPr b="0" lang="en-US" sz="10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sp>
            <p:nvSpPr>
              <p:cNvPr id="96" name="Freeform 244"/>
              <p:cNvSpPr/>
              <p:nvPr/>
            </p:nvSpPr>
            <p:spPr>
              <a:xfrm rot="300000">
                <a:off x="3801600" y="1114920"/>
                <a:ext cx="308880" cy="217440"/>
              </a:xfrm>
              <a:custGeom>
                <a:avLst/>
                <a:gdLst>
                  <a:gd name="textAreaLeft" fmla="*/ 0 w 308880"/>
                  <a:gd name="textAreaRight" fmla="*/ 309240 w 308880"/>
                  <a:gd name="textAreaTop" fmla="*/ 0 h 217440"/>
                  <a:gd name="textAreaBottom" fmla="*/ 217800 h 217440"/>
                </a:gdLst>
                <a:ahLst/>
                <a:rect l="textAreaLeft" t="textAreaTop" r="textAreaRight" b="textAreaBottom"/>
                <a:pathLst>
                  <a:path w="961" h="401">
                    <a:moveTo>
                      <a:pt x="0" y="401"/>
                    </a:moveTo>
                    <a:cubicBezTo>
                      <a:pt x="60" y="321"/>
                      <a:pt x="121" y="242"/>
                      <a:pt x="227" y="219"/>
                    </a:cubicBezTo>
                    <a:cubicBezTo>
                      <a:pt x="333" y="196"/>
                      <a:pt x="522" y="295"/>
                      <a:pt x="635" y="265"/>
                    </a:cubicBezTo>
                    <a:cubicBezTo>
                      <a:pt x="748" y="235"/>
                      <a:pt x="855" y="76"/>
                      <a:pt x="908" y="38"/>
                    </a:cubicBezTo>
                    <a:cubicBezTo>
                      <a:pt x="961" y="0"/>
                      <a:pt x="957" y="19"/>
                      <a:pt x="953" y="38"/>
                    </a:cubicBezTo>
                  </a:path>
                </a:pathLst>
              </a:custGeom>
              <a:noFill/>
              <a:ln w="63360">
                <a:solidFill>
                  <a:srgbClr val="ff0000"/>
                </a:solidFill>
                <a:prstDash val="sysDot"/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" name="Oval 229"/>
              <p:cNvSpPr/>
              <p:nvPr/>
            </p:nvSpPr>
            <p:spPr>
              <a:xfrm rot="7740000">
                <a:off x="3830760" y="1515240"/>
                <a:ext cx="340200" cy="239400"/>
              </a:xfrm>
              <a:prstGeom prst="ellipse">
                <a:avLst/>
              </a:prstGeom>
              <a:solidFill>
                <a:srgbClr val="008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 vert="eaVert" rot="10800000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" name="Oval 232"/>
              <p:cNvSpPr/>
              <p:nvPr/>
            </p:nvSpPr>
            <p:spPr>
              <a:xfrm rot="19680000">
                <a:off x="4102200" y="1287360"/>
                <a:ext cx="266040" cy="4323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" name="Text Box 245"/>
              <p:cNvSpPr/>
              <p:nvPr/>
            </p:nvSpPr>
            <p:spPr>
              <a:xfrm rot="3240000">
                <a:off x="3952440" y="1377000"/>
                <a:ext cx="57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ffffff"/>
                    </a:solidFill>
                    <a:latin typeface="Times New Roman"/>
                  </a:rPr>
                  <a:t>PCBP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sp>
        <p:nvSpPr>
          <p:cNvPr id="100" name="Rectangle 90"/>
          <p:cNvSpPr/>
          <p:nvPr/>
        </p:nvSpPr>
        <p:spPr>
          <a:xfrm>
            <a:off x="277920" y="5328360"/>
            <a:ext cx="65055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ugre S1 PCBP1 increased p27 mRNA stability in A2780, DLD-1 and MDA-MB-231 cells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(A). Schematic procedure of isolation and identification of PCBP1 bound RNA transcripts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(B). Semi-quantitative RT-PCR detection of p27 mRNA levels in the indicated cell lines. A positive correlation between PCBP1 and p27 mRNA level is observed in these cell line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01" name="组合 1"/>
          <p:cNvGrpSpPr/>
          <p:nvPr/>
        </p:nvGrpSpPr>
        <p:grpSpPr>
          <a:xfrm>
            <a:off x="153000" y="3385440"/>
            <a:ext cx="6660720" cy="1802880"/>
            <a:chOff x="153000" y="3385440"/>
            <a:chExt cx="6660720" cy="1802880"/>
          </a:xfrm>
        </p:grpSpPr>
        <p:grpSp>
          <p:nvGrpSpPr>
            <p:cNvPr id="102" name="组合 28"/>
            <p:cNvGrpSpPr/>
            <p:nvPr/>
          </p:nvGrpSpPr>
          <p:grpSpPr>
            <a:xfrm>
              <a:off x="519480" y="3385440"/>
              <a:ext cx="6294240" cy="1802880"/>
              <a:chOff x="519480" y="3385440"/>
              <a:chExt cx="6294240" cy="1802880"/>
            </a:xfrm>
          </p:grpSpPr>
          <p:pic>
            <p:nvPicPr>
              <p:cNvPr id="103" name="Picture 3" descr="G:\My files\中大中山医学院\Pictures\Agrose Eleto\2016 补\20160409-231-GFP-PCBP1-1.jpg"/>
              <p:cNvPicPr/>
              <p:nvPr/>
            </p:nvPicPr>
            <p:blipFill>
              <a:blip r:embed="rId1"/>
              <a:srcRect l="46722" t="53640" r="3099" b="23186"/>
              <a:stretch/>
            </p:blipFill>
            <p:spPr>
              <a:xfrm>
                <a:off x="1562400" y="4285080"/>
                <a:ext cx="1082520" cy="304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4" name="Picture 2" descr="G:\My files\中大中山医学院\Pictures\Agrose Eleto\2016 补\20160329-231-GFP-PCBP1-DLD1-KD-GFP-PCBP1.jpg"/>
              <p:cNvPicPr/>
              <p:nvPr/>
            </p:nvPicPr>
            <p:blipFill>
              <a:blip r:embed="rId2"/>
              <a:srcRect l="8947" t="44659" r="77336" b="35899"/>
              <a:stretch/>
            </p:blipFill>
            <p:spPr>
              <a:xfrm>
                <a:off x="1578240" y="4608720"/>
                <a:ext cx="1066680" cy="288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5" name="TextBox 34"/>
              <p:cNvSpPr/>
              <p:nvPr/>
            </p:nvSpPr>
            <p:spPr>
              <a:xfrm rot="16200000">
                <a:off x="1596240" y="3956040"/>
                <a:ext cx="494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FP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" name="TextBox 35"/>
              <p:cNvSpPr/>
              <p:nvPr/>
            </p:nvSpPr>
            <p:spPr>
              <a:xfrm rot="16200000">
                <a:off x="1981440" y="3857040"/>
                <a:ext cx="689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CBP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" name="TextBox 36"/>
              <p:cNvSpPr/>
              <p:nvPr/>
            </p:nvSpPr>
            <p:spPr>
              <a:xfrm>
                <a:off x="1703160" y="4894920"/>
                <a:ext cx="82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DA 23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" name="TextBox 37"/>
              <p:cNvSpPr/>
              <p:nvPr/>
            </p:nvSpPr>
            <p:spPr>
              <a:xfrm rot="16200000">
                <a:off x="602280" y="3944880"/>
                <a:ext cx="494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FP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9" name="TextBox 38"/>
              <p:cNvSpPr/>
              <p:nvPr/>
            </p:nvSpPr>
            <p:spPr>
              <a:xfrm rot="16200000">
                <a:off x="932040" y="3853440"/>
                <a:ext cx="689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CBP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pic>
            <p:nvPicPr>
              <p:cNvPr id="110" name="Picture 6" descr="G:\My files\中大中山医学院\Pictures\Agrose Eleto\2016 补\20160404a2780 GFP-PCBP1-KH1 FOR GAPDH.jpg"/>
              <p:cNvPicPr/>
              <p:nvPr/>
            </p:nvPicPr>
            <p:blipFill>
              <a:blip r:embed="rId3"/>
              <a:srcRect l="31713" t="35378" r="30130" b="37537"/>
              <a:stretch/>
            </p:blipFill>
            <p:spPr>
              <a:xfrm>
                <a:off x="519480" y="4615200"/>
                <a:ext cx="1006560" cy="277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1" name="Picture 3" descr="G:\My files\中大中山医学院\Pictures\Agrose Eleto\2016 补\20160405 a2780 GFP-PCBP1-KH1 2 FOR p27.jpg"/>
              <p:cNvPicPr/>
              <p:nvPr/>
            </p:nvPicPr>
            <p:blipFill>
              <a:blip r:embed="rId4"/>
              <a:srcRect l="63772" t="40122" r="18010" b="41997"/>
              <a:stretch/>
            </p:blipFill>
            <p:spPr>
              <a:xfrm>
                <a:off x="519480" y="4281840"/>
                <a:ext cx="1006560" cy="314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2" name="TextBox 41"/>
              <p:cNvSpPr/>
              <p:nvPr/>
            </p:nvSpPr>
            <p:spPr>
              <a:xfrm>
                <a:off x="6091920" y="4297680"/>
                <a:ext cx="444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27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3" name="TextBox 42"/>
              <p:cNvSpPr/>
              <p:nvPr/>
            </p:nvSpPr>
            <p:spPr>
              <a:xfrm>
                <a:off x="6082920" y="4638960"/>
                <a:ext cx="730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APDH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pic>
            <p:nvPicPr>
              <p:cNvPr id="114" name="Picture 2" descr="G:\My files\中大中山医学院\Pictures\Agrose Eleto\2016 补\20160329-231-GFP-PCBP1-DLD1-KD-GFP-PCBP1.jpg"/>
              <p:cNvPicPr/>
              <p:nvPr/>
            </p:nvPicPr>
            <p:blipFill>
              <a:blip r:embed="rId5"/>
              <a:srcRect l="21719" t="43951" r="65227" b="38617"/>
              <a:stretch/>
            </p:blipFill>
            <p:spPr>
              <a:xfrm>
                <a:off x="2683440" y="4618440"/>
                <a:ext cx="1101600" cy="280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5" name="TextBox 44"/>
              <p:cNvSpPr/>
              <p:nvPr/>
            </p:nvSpPr>
            <p:spPr>
              <a:xfrm>
                <a:off x="730440" y="4890600"/>
                <a:ext cx="631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2780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6" name="TextBox 45"/>
              <p:cNvSpPr/>
              <p:nvPr/>
            </p:nvSpPr>
            <p:spPr>
              <a:xfrm rot="16200000">
                <a:off x="3150000" y="3856320"/>
                <a:ext cx="689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CBP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7" name="TextBox 46"/>
              <p:cNvSpPr/>
              <p:nvPr/>
            </p:nvSpPr>
            <p:spPr>
              <a:xfrm rot="16200000">
                <a:off x="2725200" y="3968640"/>
                <a:ext cx="494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FP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" name="TextBox 47"/>
              <p:cNvSpPr/>
              <p:nvPr/>
            </p:nvSpPr>
            <p:spPr>
              <a:xfrm>
                <a:off x="2963880" y="4905720"/>
                <a:ext cx="628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LD-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pic>
            <p:nvPicPr>
              <p:cNvPr id="119" name="Picture 4" descr="G:\My files\中大中山医学院\Pictures\Agrose Eleto\2016 补\20160330-231-GFP-PCBP1---DLD1-KD-GFP-PCBP1-p27-GAPDH-2.jpg"/>
              <p:cNvPicPr/>
              <p:nvPr/>
            </p:nvPicPr>
            <p:blipFill>
              <a:blip r:embed="rId6"/>
              <a:srcRect l="68460" t="78795" r="25742" b="17850"/>
              <a:stretch/>
            </p:blipFill>
            <p:spPr>
              <a:xfrm>
                <a:off x="3859920" y="4608720"/>
                <a:ext cx="1150920" cy="3031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0" name="TextBox 49"/>
              <p:cNvSpPr/>
              <p:nvPr/>
            </p:nvSpPr>
            <p:spPr>
              <a:xfrm rot="16200000">
                <a:off x="3693600" y="3723120"/>
                <a:ext cx="951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CBP1 KD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" name="TextBox 50"/>
              <p:cNvSpPr/>
              <p:nvPr/>
            </p:nvSpPr>
            <p:spPr>
              <a:xfrm rot="16200000">
                <a:off x="4385880" y="3975120"/>
                <a:ext cx="494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FP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" name="TextBox 51"/>
              <p:cNvSpPr/>
              <p:nvPr/>
            </p:nvSpPr>
            <p:spPr>
              <a:xfrm>
                <a:off x="4185720" y="4911840"/>
                <a:ext cx="628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LD-1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pic>
            <p:nvPicPr>
              <p:cNvPr id="123" name="Picture 4" descr="2015-04-02-A2780-KD-GFP-ActD--0-8-12h-GAPDH-55C-2"/>
              <p:cNvPicPr/>
              <p:nvPr/>
            </p:nvPicPr>
            <p:blipFill>
              <a:blip r:embed="rId7"/>
              <a:srcRect l="14854" t="41194" r="63184" b="51091"/>
              <a:stretch/>
            </p:blipFill>
            <p:spPr>
              <a:xfrm>
                <a:off x="5036400" y="4618440"/>
                <a:ext cx="1109520" cy="290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4" name="Picture 5" descr="2015-04-03-A2780-KD-GFP-ActD--0-8-12h-p27-54_55_58C-2"/>
              <p:cNvPicPr/>
              <p:nvPr/>
            </p:nvPicPr>
            <p:blipFill>
              <a:blip r:embed="rId8"/>
              <a:srcRect l="12567" t="49377" r="65523" b="40815"/>
              <a:stretch/>
            </p:blipFill>
            <p:spPr>
              <a:xfrm>
                <a:off x="5036400" y="4285080"/>
                <a:ext cx="1109520" cy="301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5" name="TextBox 54"/>
              <p:cNvSpPr/>
              <p:nvPr/>
            </p:nvSpPr>
            <p:spPr>
              <a:xfrm rot="16200000">
                <a:off x="4849560" y="3723120"/>
                <a:ext cx="951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CBP1 KD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" name="TextBox 55"/>
              <p:cNvSpPr/>
              <p:nvPr/>
            </p:nvSpPr>
            <p:spPr>
              <a:xfrm rot="16200000">
                <a:off x="5599080" y="3965400"/>
                <a:ext cx="494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FP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" name="TextBox 56"/>
              <p:cNvSpPr/>
              <p:nvPr/>
            </p:nvSpPr>
            <p:spPr>
              <a:xfrm>
                <a:off x="5299920" y="4911840"/>
                <a:ext cx="631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2780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pic>
            <p:nvPicPr>
              <p:cNvPr id="128" name="Picture 2" descr="G:\My files\中大中山医学院\Pictures\Agrose Eleto\2016 补\20160329-231-GFP-PCBP1-DLD1-KD-GFP-PCBP1-M.jpg"/>
              <p:cNvPicPr/>
              <p:nvPr/>
            </p:nvPicPr>
            <p:blipFill>
              <a:blip r:embed="rId9"/>
              <a:srcRect l="27709" t="40463" r="58834" b="30818"/>
              <a:stretch/>
            </p:blipFill>
            <p:spPr>
              <a:xfrm>
                <a:off x="2683440" y="4285080"/>
                <a:ext cx="1101600" cy="304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9" name="Picture 4" descr="G:\My files\中大中山医学院\Pictures\Agrose Eleto\2016 补\20160330-231-GFP-PCBP1---DLD1-KD-GFP-PCBP1-p27-GAPDH-3-MM.jpg"/>
              <p:cNvPicPr/>
              <p:nvPr/>
            </p:nvPicPr>
            <p:blipFill>
              <a:blip r:embed="rId10">
                <a:lum contrast="-2000"/>
              </a:blip>
              <a:srcRect l="27542" t="66317" r="0" b="22054"/>
              <a:stretch/>
            </p:blipFill>
            <p:spPr>
              <a:xfrm>
                <a:off x="3859920" y="4285080"/>
                <a:ext cx="1150920" cy="30132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30" name="TextBox 99"/>
            <p:cNvSpPr/>
            <p:nvPr/>
          </p:nvSpPr>
          <p:spPr>
            <a:xfrm>
              <a:off x="153000" y="4299480"/>
              <a:ext cx="441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47 ­-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1" name="TextBox 100"/>
            <p:cNvSpPr/>
            <p:nvPr/>
          </p:nvSpPr>
          <p:spPr>
            <a:xfrm>
              <a:off x="153000" y="4641120"/>
              <a:ext cx="470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452 - ­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TextBox 101"/>
            <p:cNvSpPr/>
            <p:nvPr/>
          </p:nvSpPr>
          <p:spPr>
            <a:xfrm>
              <a:off x="272880" y="4050720"/>
              <a:ext cx="336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p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33" name="TextBox 1"/>
          <p:cNvSpPr/>
          <p:nvPr/>
        </p:nvSpPr>
        <p:spPr>
          <a:xfrm>
            <a:off x="202680" y="33814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9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dministrator</dc:creator>
  <dc:description/>
  <dc:language>en-US</dc:language>
  <cp:lastModifiedBy>Hongshun</cp:lastModifiedBy>
  <dcterms:modified xsi:type="dcterms:W3CDTF">2018-06-25T03:08:35Z</dcterms:modified>
  <cp:revision>185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